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10"/>
  </p:notesMasterIdLst>
  <p:sldIdLst>
    <p:sldId id="266" r:id="rId3"/>
    <p:sldId id="826" r:id="rId4"/>
    <p:sldId id="832" r:id="rId5"/>
    <p:sldId id="833" r:id="rId6"/>
    <p:sldId id="830" r:id="rId7"/>
    <p:sldId id="831" r:id="rId8"/>
    <p:sldId id="827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EDEDE"/>
    <a:srgbClr val="BEBEBE"/>
    <a:srgbClr val="A5A5A5"/>
    <a:srgbClr val="5959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66" d="100"/>
          <a:sy n="66" d="100"/>
        </p:scale>
        <p:origin x="1250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90A02C-1167-47AF-9070-06F5C3D8E32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28C4B6-D027-405A-82AA-0097A278B9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86005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471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186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833111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5" name="Rectangle 7"/>
          <p:cNvSpPr>
            <a:spLocks noChangeArrowheads="1"/>
          </p:cNvSpPr>
          <p:nvPr/>
        </p:nvSpPr>
        <p:spPr bwMode="auto">
          <a:xfrm>
            <a:off x="0" y="1376772"/>
            <a:ext cx="1763713" cy="2519239"/>
          </a:xfrm>
          <a:prstGeom prst="rect">
            <a:avLst/>
          </a:prstGeom>
          <a:solidFill>
            <a:srgbClr val="9CB66D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endParaRPr lang="ja-JP" altLang="ja-JP" dirty="0"/>
          </a:p>
        </p:txBody>
      </p:sp>
      <p:sp>
        <p:nvSpPr>
          <p:cNvPr id="12296" name="Rectangle 8"/>
          <p:cNvSpPr>
            <a:spLocks noChangeArrowheads="1"/>
          </p:cNvSpPr>
          <p:nvPr/>
        </p:nvSpPr>
        <p:spPr bwMode="auto">
          <a:xfrm>
            <a:off x="1749425" y="1376772"/>
            <a:ext cx="7394575" cy="2519239"/>
          </a:xfrm>
          <a:prstGeom prst="rect">
            <a:avLst/>
          </a:prstGeom>
          <a:solidFill>
            <a:srgbClr val="23651C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endParaRPr lang="ja-JP" altLang="ja-JP" dirty="0"/>
          </a:p>
        </p:txBody>
      </p:sp>
      <p:sp>
        <p:nvSpPr>
          <p:cNvPr id="1229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1871663" y="1473610"/>
            <a:ext cx="6948487" cy="1061501"/>
          </a:xfrm>
        </p:spPr>
        <p:txBody>
          <a:bodyPr anchor="t"/>
          <a:lstStyle>
            <a:lvl1pPr>
              <a:defRPr sz="3200"/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1873250" y="2697572"/>
            <a:ext cx="6946900" cy="530752"/>
          </a:xfrm>
        </p:spPr>
        <p:txBody>
          <a:bodyPr/>
          <a:lstStyle>
            <a:lvl1pPr marL="0" indent="0">
              <a:defRPr sz="2400">
                <a:solidFill>
                  <a:schemeClr val="bg1"/>
                </a:solidFill>
              </a:defRPr>
            </a:lvl1pPr>
          </a:lstStyle>
          <a:p>
            <a:r>
              <a:rPr lang="ja-JP" altLang="en-US" dirty="0"/>
              <a:t>マスタ サブタイトルの書式設定</a:t>
            </a:r>
          </a:p>
        </p:txBody>
      </p:sp>
      <p:pic>
        <p:nvPicPr>
          <p:cNvPr id="12315" name="Picture 27" descr="logomark7"/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52636"/>
            <a:ext cx="3025031" cy="807120"/>
          </a:xfrm>
          <a:prstGeom prst="rect">
            <a:avLst/>
          </a:prstGeom>
          <a:noFill/>
        </p:spPr>
      </p:pic>
      <p:pic>
        <p:nvPicPr>
          <p:cNvPr id="7" name="Picture 2"/>
          <p:cNvPicPr>
            <a:picLocks noChangeAspect="1" noChangeArrowheads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508" y="153144"/>
            <a:ext cx="791580" cy="7915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41220356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>
            <a:extLst>
              <a:ext uri="{FF2B5EF4-FFF2-40B4-BE49-F238E27FC236}">
                <a16:creationId xmlns:a16="http://schemas.microsoft.com/office/drawing/2014/main" id="{C6E1B17F-59B9-4DFD-8E3F-6CAA8CF53AB3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2A6797D7-2B9C-4153-B3EF-8B5BA34C9DD0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69106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948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66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840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381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40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839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983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464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41BC2-BDD9-41A5-8B0B-C9AD26BDC634}" type="datetimeFigureOut">
              <a:rPr kumimoji="1" lang="ja-JP" altLang="en-US" smtClean="0"/>
              <a:t>2020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1EA38-2565-4E7C-B35E-86C77DEBE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4190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74" name="Rectangle 10"/>
          <p:cNvSpPr>
            <a:spLocks noChangeArrowheads="1"/>
          </p:cNvSpPr>
          <p:nvPr/>
        </p:nvSpPr>
        <p:spPr bwMode="auto">
          <a:xfrm>
            <a:off x="0" y="908050"/>
            <a:ext cx="9144000" cy="73025"/>
          </a:xfrm>
          <a:prstGeom prst="rect">
            <a:avLst/>
          </a:prstGeom>
          <a:solidFill>
            <a:srgbClr val="9CB66D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endParaRPr lang="ja-JP" altLang="ja-JP" dirty="0"/>
          </a:p>
        </p:txBody>
      </p:sp>
      <p:sp>
        <p:nvSpPr>
          <p:cNvPr id="11271" name="Rectangle 7"/>
          <p:cNvSpPr>
            <a:spLocks noChangeArrowheads="1"/>
          </p:cNvSpPr>
          <p:nvPr/>
        </p:nvSpPr>
        <p:spPr bwMode="auto">
          <a:xfrm>
            <a:off x="0" y="0"/>
            <a:ext cx="9144000" cy="908050"/>
          </a:xfrm>
          <a:prstGeom prst="rect">
            <a:avLst/>
          </a:prstGeom>
          <a:solidFill>
            <a:srgbClr val="23651C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endParaRPr lang="ja-JP" altLang="ja-JP" dirty="0"/>
          </a:p>
        </p:txBody>
      </p:sp>
      <p:sp>
        <p:nvSpPr>
          <p:cNvPr id="1126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863588" y="260648"/>
            <a:ext cx="7561262" cy="509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dirty="0"/>
              <a:t>マスタ タイトルの書式設定</a:t>
            </a:r>
          </a:p>
        </p:txBody>
      </p:sp>
      <p:sp>
        <p:nvSpPr>
          <p:cNvPr id="1126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79388" y="1125538"/>
            <a:ext cx="8785225" cy="4967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11278" name="Text Box 14"/>
          <p:cNvSpPr txBox="1">
            <a:spLocks noChangeArrowheads="1"/>
          </p:cNvSpPr>
          <p:nvPr/>
        </p:nvSpPr>
        <p:spPr bwMode="auto">
          <a:xfrm>
            <a:off x="4264025" y="-282575"/>
            <a:ext cx="3116263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l"/>
            <a:endParaRPr lang="ja-JP" altLang="ja-JP" dirty="0"/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04" y="45132"/>
            <a:ext cx="791580" cy="7915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27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234363" y="44450"/>
            <a:ext cx="801687" cy="484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2000">
                <a:solidFill>
                  <a:schemeClr val="bg1"/>
                </a:solidFill>
                <a:latin typeface="ヒラギノ丸ゴ Pro W4"/>
                <a:ea typeface="ヒラギノ丸ゴ Pro W4"/>
                <a:cs typeface="ヒラギノ丸ゴ Pro W4"/>
              </a:defRPr>
            </a:lvl1pPr>
          </a:lstStyle>
          <a:p>
            <a:fld id="{84F2E3BF-CA5C-4D7E-BA5D-6E6085B8BB3D}" type="slidenum">
              <a:rPr lang="en-US" altLang="ja-JP" smtClean="0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91270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5" r:id="rId2"/>
  </p:sldLayoutIdLst>
  <p:hf hdr="0" ftr="0" dt="0"/>
  <p:txStyles>
    <p:titleStyle>
      <a:lvl1pPr algn="l" rtl="0" eaLnBrk="1" fontAlgn="base" hangingPunct="1">
        <a:spcBef>
          <a:spcPct val="0"/>
        </a:spcBef>
        <a:spcAft>
          <a:spcPct val="0"/>
        </a:spcAft>
        <a:defRPr kumimoji="1" sz="2800">
          <a:solidFill>
            <a:schemeClr val="bg1"/>
          </a:solidFill>
          <a:latin typeface="ヒラギノ丸ゴ Pro W4"/>
          <a:ea typeface="ヒラギノ丸ゴ Pro W4"/>
          <a:cs typeface="ヒラギノ丸ゴ Pro W4"/>
        </a:defRPr>
      </a:lvl1pPr>
      <a:lvl2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2pPr>
      <a:lvl3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3pPr>
      <a:lvl4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4pPr>
      <a:lvl5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Franklin Gothic Demi" pitchFamily="34" charset="0"/>
          <a:ea typeface="ＭＳ Ｐゴシック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defRPr kumimoji="1" sz="2800">
          <a:solidFill>
            <a:schemeClr val="tx1"/>
          </a:solidFill>
          <a:latin typeface="ヒラギノ丸ゴ Pro W4"/>
          <a:ea typeface="ヒラギノ丸ゴ Pro W4"/>
          <a:cs typeface="ヒラギノ丸ゴ Pro W4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har char="–"/>
        <a:defRPr kumimoji="1" sz="2400">
          <a:solidFill>
            <a:schemeClr val="tx1"/>
          </a:solidFill>
          <a:latin typeface="ヒラギノ丸ゴ Pro W4"/>
          <a:ea typeface="ヒラギノ丸ゴ Pro W4"/>
          <a:cs typeface="ヒラギノ丸ゴ Pro W4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kumimoji="1" sz="2000">
          <a:solidFill>
            <a:schemeClr val="tx1"/>
          </a:solidFill>
          <a:latin typeface="ヒラギノ丸ゴ Pro W4"/>
          <a:ea typeface="ヒラギノ丸ゴ Pro W4"/>
          <a:cs typeface="ヒラギノ丸ゴ Pro W4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ヒラギノ丸ゴ Pro W4"/>
          <a:ea typeface="ヒラギノ丸ゴ Pro W4"/>
          <a:cs typeface="ヒラギノ丸ゴ Pro W4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ヒラギノ丸ゴ Pro W4"/>
          <a:ea typeface="ヒラギノ丸ゴ Pro W4"/>
          <a:cs typeface="ヒラギノ丸ゴ Pro W4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F3D2E9-A33F-4ADA-B277-5DA2768D0C59}"/>
              </a:ext>
            </a:extLst>
          </p:cNvPr>
          <p:cNvSpPr txBox="1"/>
          <p:nvPr/>
        </p:nvSpPr>
        <p:spPr>
          <a:xfrm>
            <a:off x="0" y="12263"/>
            <a:ext cx="33979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 Dose constraints for planning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B5DB249-19B3-4C3B-A1AE-2E8CB5A920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7597028"/>
              </p:ext>
            </p:extLst>
          </p:nvPr>
        </p:nvGraphicFramePr>
        <p:xfrm>
          <a:off x="1201119" y="542509"/>
          <a:ext cx="4566757" cy="54254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005911">
                  <a:extLst>
                    <a:ext uri="{9D8B030D-6E8A-4147-A177-3AD203B41FA5}">
                      <a16:colId xmlns:a16="http://schemas.microsoft.com/office/drawing/2014/main" val="2234154908"/>
                    </a:ext>
                  </a:extLst>
                </a:gridCol>
                <a:gridCol w="533618">
                  <a:extLst>
                    <a:ext uri="{9D8B030D-6E8A-4147-A177-3AD203B41FA5}">
                      <a16:colId xmlns:a16="http://schemas.microsoft.com/office/drawing/2014/main" val="1983178117"/>
                    </a:ext>
                  </a:extLst>
                </a:gridCol>
                <a:gridCol w="487395">
                  <a:extLst>
                    <a:ext uri="{9D8B030D-6E8A-4147-A177-3AD203B41FA5}">
                      <a16:colId xmlns:a16="http://schemas.microsoft.com/office/drawing/2014/main" val="1340401255"/>
                    </a:ext>
                  </a:extLst>
                </a:gridCol>
                <a:gridCol w="569013">
                  <a:extLst>
                    <a:ext uri="{9D8B030D-6E8A-4147-A177-3AD203B41FA5}">
                      <a16:colId xmlns:a16="http://schemas.microsoft.com/office/drawing/2014/main" val="2637353676"/>
                    </a:ext>
                  </a:extLst>
                </a:gridCol>
                <a:gridCol w="501740">
                  <a:extLst>
                    <a:ext uri="{9D8B030D-6E8A-4147-A177-3AD203B41FA5}">
                      <a16:colId xmlns:a16="http://schemas.microsoft.com/office/drawing/2014/main" val="1074486868"/>
                    </a:ext>
                  </a:extLst>
                </a:gridCol>
                <a:gridCol w="469080">
                  <a:extLst>
                    <a:ext uri="{9D8B030D-6E8A-4147-A177-3AD203B41FA5}">
                      <a16:colId xmlns:a16="http://schemas.microsoft.com/office/drawing/2014/main" val="61256861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A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iteria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ptable</a:t>
                      </a:r>
                    </a:p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iteria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2722542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instem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6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851494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instem + 3 mm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6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6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00992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c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6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96816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inal cor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46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703679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inal cord + 3 mm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253902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11416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c nerve / Chiasm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46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710567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c nerve / Chiasm + 3 mm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451834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y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45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4839865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i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a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7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7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71858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c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7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3854895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otid glan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26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3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78568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mandibular glan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39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4707593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cavity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45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2055069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rynx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low as possibl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538695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ryngeal constrictor muscl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low as possibl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3945924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roi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low as possibl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84221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vula / Soft palat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ea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low as possibl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3628906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n</a:t>
                      </a:r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3 mm thickness from the skin surface)</a:t>
                      </a:r>
                      <a:endParaRPr kumimoji="1" lang="ja-JP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kumimoji="1" lang="en-US" altLang="ja-JP" sz="9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Gy(E)</a:t>
                      </a:r>
                      <a:endParaRPr kumimoji="1" lang="ja-JP" altLang="en-US" sz="9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1.5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0037043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kumimoji="1" lang="en-US" altLang="ja-JP" sz="9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Gy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6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8445844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kumimoji="1" lang="en-US" altLang="ja-JP" sz="9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y(E)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15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31264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kumimoji="1" lang="en-US" altLang="ja-JP" sz="9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Gy(E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3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229741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2640719-6B79-4CAD-B46B-CD70F91C212D}"/>
              </a:ext>
            </a:extLst>
          </p:cNvPr>
          <p:cNvSpPr txBox="1"/>
          <p:nvPr/>
        </p:nvSpPr>
        <p:spPr>
          <a:xfrm>
            <a:off x="74543" y="6455700"/>
            <a:ext cx="8994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OAR = organ at risk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ax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he maximum dose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) = gray (cobalt gray equivalent), D1cc =  the maximum dose received by the highest irradiated volumes of 1 cc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he mean dose, V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xGy(E)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he volume receiving more than XX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5565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F3D2E9-A33F-4ADA-B277-5DA2768D0C59}"/>
              </a:ext>
            </a:extLst>
          </p:cNvPr>
          <p:cNvSpPr txBox="1"/>
          <p:nvPr/>
        </p:nvSpPr>
        <p:spPr>
          <a:xfrm>
            <a:off x="0" y="12263"/>
            <a:ext cx="4174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 Schematic of the dose delivery approach.</a:t>
            </a:r>
          </a:p>
        </p:txBody>
      </p:sp>
      <p:sp>
        <p:nvSpPr>
          <p:cNvPr id="3" name="右矢印 4">
            <a:extLst>
              <a:ext uri="{FF2B5EF4-FFF2-40B4-BE49-F238E27FC236}">
                <a16:creationId xmlns:a16="http://schemas.microsoft.com/office/drawing/2014/main" id="{64E677F5-87DC-4188-85BB-7B9B64273307}"/>
              </a:ext>
            </a:extLst>
          </p:cNvPr>
          <p:cNvSpPr/>
          <p:nvPr/>
        </p:nvSpPr>
        <p:spPr bwMode="auto">
          <a:xfrm>
            <a:off x="1300047" y="2286417"/>
            <a:ext cx="3046513" cy="1512168"/>
          </a:xfrm>
          <a:prstGeom prst="rightArrow">
            <a:avLst>
              <a:gd name="adj1" fmla="val 72786"/>
              <a:gd name="adj2" fmla="val 22832"/>
            </a:avLst>
          </a:prstGeom>
          <a:ln>
            <a:headEnd type="none" w="med" len="med"/>
            <a:tailEnd type="none" w="med" len="med"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右矢印 5">
            <a:extLst>
              <a:ext uri="{FF2B5EF4-FFF2-40B4-BE49-F238E27FC236}">
                <a16:creationId xmlns:a16="http://schemas.microsoft.com/office/drawing/2014/main" id="{27901317-7A15-4ED4-9B6B-CED0C8DFE3DA}"/>
              </a:ext>
            </a:extLst>
          </p:cNvPr>
          <p:cNvSpPr/>
          <p:nvPr/>
        </p:nvSpPr>
        <p:spPr bwMode="auto">
          <a:xfrm>
            <a:off x="4396391" y="2286417"/>
            <a:ext cx="1952565" cy="1512168"/>
          </a:xfrm>
          <a:prstGeom prst="rightArrow">
            <a:avLst>
              <a:gd name="adj1" fmla="val 72786"/>
              <a:gd name="adj2" fmla="val 22832"/>
            </a:avLst>
          </a:prstGeom>
          <a:solidFill>
            <a:srgbClr val="BEBEBE"/>
          </a:solidFill>
          <a:ln>
            <a:headEnd type="none" w="med" len="med"/>
            <a:tailEnd type="none" w="med" len="med"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三角形 6">
            <a:extLst>
              <a:ext uri="{FF2B5EF4-FFF2-40B4-BE49-F238E27FC236}">
                <a16:creationId xmlns:a16="http://schemas.microsoft.com/office/drawing/2014/main" id="{31504963-86D1-47BD-AD51-4138964BB0FB}"/>
              </a:ext>
            </a:extLst>
          </p:cNvPr>
          <p:cNvSpPr/>
          <p:nvPr/>
        </p:nvSpPr>
        <p:spPr bwMode="auto">
          <a:xfrm rot="10800000">
            <a:off x="597969" y="1642714"/>
            <a:ext cx="504056" cy="643703"/>
          </a:xfrm>
          <a:prstGeom prst="triangle">
            <a:avLst/>
          </a:prstGeom>
          <a:ln>
            <a:headEnd type="none" w="med" len="med"/>
            <a:tailEnd type="none" w="med" len="med"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9E0097A-A75B-469E-9AFA-4AAE894C2D30}"/>
              </a:ext>
            </a:extLst>
          </p:cNvPr>
          <p:cNvSpPr txBox="1"/>
          <p:nvPr/>
        </p:nvSpPr>
        <p:spPr>
          <a:xfrm>
            <a:off x="330476" y="1745652"/>
            <a:ext cx="753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CT</a:t>
            </a:r>
          </a:p>
        </p:txBody>
      </p:sp>
      <p:sp>
        <p:nvSpPr>
          <p:cNvPr id="8" name="三角形 9">
            <a:extLst>
              <a:ext uri="{FF2B5EF4-FFF2-40B4-BE49-F238E27FC236}">
                <a16:creationId xmlns:a16="http://schemas.microsoft.com/office/drawing/2014/main" id="{0C54704F-B66D-4D8A-814D-3478C66D6009}"/>
              </a:ext>
            </a:extLst>
          </p:cNvPr>
          <p:cNvSpPr/>
          <p:nvPr/>
        </p:nvSpPr>
        <p:spPr bwMode="auto">
          <a:xfrm rot="10800000">
            <a:off x="3302444" y="1642714"/>
            <a:ext cx="504056" cy="643703"/>
          </a:xfrm>
          <a:prstGeom prst="triangle">
            <a:avLst/>
          </a:prstGeom>
          <a:solidFill>
            <a:srgbClr val="BEBEBE"/>
          </a:solidFill>
          <a:ln>
            <a:headEnd type="none" w="med" len="med"/>
            <a:tailEnd type="none" w="med" len="med"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2F60DB-195B-49A0-A506-D4172F551E6C}"/>
              </a:ext>
            </a:extLst>
          </p:cNvPr>
          <p:cNvSpPr txBox="1"/>
          <p:nvPr/>
        </p:nvSpPr>
        <p:spPr>
          <a:xfrm>
            <a:off x="2892070" y="1732184"/>
            <a:ext cx="910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CT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9CD407B-54FF-4E75-8A91-BE85C8BC8E86}"/>
              </a:ext>
            </a:extLst>
          </p:cNvPr>
          <p:cNvSpPr txBox="1"/>
          <p:nvPr/>
        </p:nvSpPr>
        <p:spPr>
          <a:xfrm>
            <a:off x="1593050" y="2762722"/>
            <a:ext cx="21602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1</a:t>
            </a:r>
            <a:r>
              <a:rPr kumimoji="1" lang="en-US" altLang="ja-JP" sz="240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st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 IMPT plan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E8C8D41-B1D2-4C7C-95F5-27215C42FD46}"/>
              </a:ext>
            </a:extLst>
          </p:cNvPr>
          <p:cNvSpPr txBox="1"/>
          <p:nvPr/>
        </p:nvSpPr>
        <p:spPr>
          <a:xfrm>
            <a:off x="4270377" y="2762722"/>
            <a:ext cx="21602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240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nd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 IMPT plan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817AC3F-AE8F-4BA9-B9B7-97F4FAD2754B}"/>
              </a:ext>
            </a:extLst>
          </p:cNvPr>
          <p:cNvSpPr txBox="1"/>
          <p:nvPr/>
        </p:nvSpPr>
        <p:spPr>
          <a:xfrm>
            <a:off x="1415658" y="3951724"/>
            <a:ext cx="2409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Low- and high-risk area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46 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GyE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/23 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fr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3C364D2-C8FB-4A57-A4B7-54C3057539F3}"/>
              </a:ext>
            </a:extLst>
          </p:cNvPr>
          <p:cNvSpPr txBox="1"/>
          <p:nvPr/>
        </p:nvSpPr>
        <p:spPr>
          <a:xfrm>
            <a:off x="4405498" y="3942601"/>
            <a:ext cx="15119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High-risk area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24 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GyE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/12 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fr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0C64F6B-B1C5-475F-A531-C3739036FAC3}"/>
              </a:ext>
            </a:extLst>
          </p:cNvPr>
          <p:cNvSpPr/>
          <p:nvPr/>
        </p:nvSpPr>
        <p:spPr bwMode="auto">
          <a:xfrm>
            <a:off x="6520627" y="2286417"/>
            <a:ext cx="2052228" cy="1512168"/>
          </a:xfrm>
          <a:prstGeom prst="rect">
            <a:avLst/>
          </a:prstGeom>
          <a:solidFill>
            <a:srgbClr val="DEDEDE"/>
          </a:solidFill>
          <a:ln>
            <a:headEnd type="none" w="med" len="med"/>
            <a:tailEnd type="none" w="med" len="med"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B7F2AF2-E079-4869-B5F5-E24613716AEF}"/>
              </a:ext>
            </a:extLst>
          </p:cNvPr>
          <p:cNvSpPr txBox="1"/>
          <p:nvPr/>
        </p:nvSpPr>
        <p:spPr>
          <a:xfrm>
            <a:off x="6603723" y="2516500"/>
            <a:ext cx="188603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Total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70 </a:t>
            </a:r>
            <a:r>
              <a:rPr kumimoji="1" lang="en-US" altLang="ja-JP" sz="24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GyE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/35 </a:t>
            </a:r>
            <a:r>
              <a:rPr kumimoji="1" lang="en-US" altLang="ja-JP" sz="24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fr</a:t>
            </a:r>
            <a:endParaRPr kumimoji="1" lang="en-US" altLang="ja-JP" sz="2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" name="下カーブ矢印 17">
            <a:extLst>
              <a:ext uri="{FF2B5EF4-FFF2-40B4-BE49-F238E27FC236}">
                <a16:creationId xmlns:a16="http://schemas.microsoft.com/office/drawing/2014/main" id="{FC385305-305C-469C-B0DC-11B64FBB8B16}"/>
              </a:ext>
            </a:extLst>
          </p:cNvPr>
          <p:cNvSpPr/>
          <p:nvPr/>
        </p:nvSpPr>
        <p:spPr bwMode="auto">
          <a:xfrm rot="2808979">
            <a:off x="1173283" y="1900783"/>
            <a:ext cx="998065" cy="555243"/>
          </a:xfrm>
          <a:prstGeom prst="curvedDownArrow">
            <a:avLst/>
          </a:prstGeom>
          <a:ln>
            <a:headEnd type="none" w="med" len="med"/>
            <a:tailEnd type="none" w="med" len="med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" name="下カーブ矢印 19">
            <a:extLst>
              <a:ext uri="{FF2B5EF4-FFF2-40B4-BE49-F238E27FC236}">
                <a16:creationId xmlns:a16="http://schemas.microsoft.com/office/drawing/2014/main" id="{D8100A59-8631-4E69-A4F9-2D4A90221A27}"/>
              </a:ext>
            </a:extLst>
          </p:cNvPr>
          <p:cNvSpPr/>
          <p:nvPr/>
        </p:nvSpPr>
        <p:spPr bwMode="auto">
          <a:xfrm rot="2808979">
            <a:off x="3979029" y="1837363"/>
            <a:ext cx="998065" cy="555243"/>
          </a:xfrm>
          <a:prstGeom prst="curvedDownArrow">
            <a:avLst/>
          </a:prstGeom>
          <a:ln>
            <a:headEnd type="none" w="med" len="med"/>
            <a:tailEnd type="none" w="med" len="med"/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6E026C8-1FA8-4DFB-BA6C-4414F851A6CF}"/>
              </a:ext>
            </a:extLst>
          </p:cNvPr>
          <p:cNvSpPr txBox="1"/>
          <p:nvPr/>
        </p:nvSpPr>
        <p:spPr>
          <a:xfrm>
            <a:off x="602086" y="1547518"/>
            <a:ext cx="450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1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st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E8A875E-A9BD-4249-B3CE-F667B2BB63D9}"/>
              </a:ext>
            </a:extLst>
          </p:cNvPr>
          <p:cNvSpPr txBox="1"/>
          <p:nvPr/>
        </p:nvSpPr>
        <p:spPr>
          <a:xfrm>
            <a:off x="3334959" y="1554437"/>
            <a:ext cx="450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4E4662B-53C3-4B6F-95D2-2F53FDDE4706}"/>
              </a:ext>
            </a:extLst>
          </p:cNvPr>
          <p:cNvSpPr txBox="1"/>
          <p:nvPr/>
        </p:nvSpPr>
        <p:spPr>
          <a:xfrm>
            <a:off x="382657" y="725312"/>
            <a:ext cx="8507895" cy="461665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 algn="ctr"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kumimoji="1" lang="en-US" altLang="ja-JP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Sequential boost 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method (two plan approach)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F058D54-AD6C-4D29-9861-3B253D34DE66}"/>
              </a:ext>
            </a:extLst>
          </p:cNvPr>
          <p:cNvSpPr/>
          <p:nvPr/>
        </p:nvSpPr>
        <p:spPr>
          <a:xfrm>
            <a:off x="382657" y="725312"/>
            <a:ext cx="8507895" cy="4356276"/>
          </a:xfrm>
          <a:prstGeom prst="rect">
            <a:avLst/>
          </a:prstGeom>
          <a:noFill/>
          <a:ln>
            <a:solidFill>
              <a:srgbClr val="A5A5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D1BBF85-76B2-4F7F-BD5E-30B5AEB795CD}"/>
              </a:ext>
            </a:extLst>
          </p:cNvPr>
          <p:cNvSpPr txBox="1"/>
          <p:nvPr/>
        </p:nvSpPr>
        <p:spPr>
          <a:xfrm>
            <a:off x="111000" y="6546736"/>
            <a:ext cx="5796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CT = computed tomography, IMPT = intensity-modulated proton therapy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E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cobalt gray equivalent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62892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F3D2E9-A33F-4ADA-B277-5DA2768D0C59}"/>
              </a:ext>
            </a:extLst>
          </p:cNvPr>
          <p:cNvSpPr txBox="1"/>
          <p:nvPr/>
        </p:nvSpPr>
        <p:spPr>
          <a:xfrm>
            <a:off x="0" y="12263"/>
            <a:ext cx="5082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 Basic policy for selection of prophylactic neck node level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B5DB249-19B3-4C3B-A1AE-2E8CB5A920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5886112"/>
              </p:ext>
            </p:extLst>
          </p:nvPr>
        </p:nvGraphicFramePr>
        <p:xfrm>
          <a:off x="674068" y="542509"/>
          <a:ext cx="7479333" cy="35966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759749">
                  <a:extLst>
                    <a:ext uri="{9D8B030D-6E8A-4147-A177-3AD203B41FA5}">
                      <a16:colId xmlns:a16="http://schemas.microsoft.com/office/drawing/2014/main" val="2234154908"/>
                    </a:ext>
                  </a:extLst>
                </a:gridCol>
                <a:gridCol w="1058437">
                  <a:extLst>
                    <a:ext uri="{9D8B030D-6E8A-4147-A177-3AD203B41FA5}">
                      <a16:colId xmlns:a16="http://schemas.microsoft.com/office/drawing/2014/main" val="2603215607"/>
                    </a:ext>
                  </a:extLst>
                </a:gridCol>
                <a:gridCol w="2861130">
                  <a:extLst>
                    <a:ext uri="{9D8B030D-6E8A-4147-A177-3AD203B41FA5}">
                      <a16:colId xmlns:a16="http://schemas.microsoft.com/office/drawing/2014/main" val="1340401255"/>
                    </a:ext>
                  </a:extLst>
                </a:gridCol>
                <a:gridCol w="2800017">
                  <a:extLst>
                    <a:ext uri="{9D8B030D-6E8A-4147-A177-3AD203B41FA5}">
                      <a16:colId xmlns:a16="http://schemas.microsoft.com/office/drawing/2014/main" val="1074486868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Category</a:t>
                      </a:r>
                    </a:p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UICC 8th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silateral Neck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alateral Neck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2722542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sopharyngeal Cancer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851494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00992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1-2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96816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3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* 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703679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opharyngeal Cancer**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253902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0-1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114167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2a-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66619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2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ording to N category on each side of the neck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ording to N category on each side of the neck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831465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3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ording to N category on each side of the neck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5437596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pharyngeal Caner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8953885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0878181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1, N2a-b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VI 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VI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0058119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2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ording to N category on each side of the neck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ording to N category on each side of the neck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8607843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3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II, III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a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(</a:t>
                      </a:r>
                      <a:r>
                        <a:rPr kumimoji="1" lang="en-US" altLang="ja-JP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Ib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) VI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ording to N category on each side of the neck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1570281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D420C0B-9846-4B3B-8D11-FF1361C5E9C4}"/>
              </a:ext>
            </a:extLst>
          </p:cNvPr>
          <p:cNvSpPr txBox="1"/>
          <p:nvPr/>
        </p:nvSpPr>
        <p:spPr>
          <a:xfrm>
            <a:off x="597684" y="4161564"/>
            <a:ext cx="755571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7800" indent="-177800"/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  The neck node level in parentheses was optional. The selection primarily depended on the location of the lymph node metastasis and the degree of progression of the primary tumor.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The selection was made based on UICC 7</a:t>
            </a:r>
            <a:r>
              <a:rPr kumimoji="1"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dition in patients with p16-positive and negative oropharyngeal cancer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719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F3D2E9-A33F-4ADA-B277-5DA2768D0C59}"/>
              </a:ext>
            </a:extLst>
          </p:cNvPr>
          <p:cNvSpPr txBox="1"/>
          <p:nvPr/>
        </p:nvSpPr>
        <p:spPr>
          <a:xfrm>
            <a:off x="0" y="12263"/>
            <a:ext cx="3078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3 Chemotherapy regimens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B5DB249-19B3-4C3B-A1AE-2E8CB5A920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5011391"/>
              </p:ext>
            </p:extLst>
          </p:nvPr>
        </p:nvGraphicFramePr>
        <p:xfrm>
          <a:off x="756030" y="620146"/>
          <a:ext cx="7395932" cy="39014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77456">
                  <a:extLst>
                    <a:ext uri="{9D8B030D-6E8A-4147-A177-3AD203B41FA5}">
                      <a16:colId xmlns:a16="http://schemas.microsoft.com/office/drawing/2014/main" val="2234154908"/>
                    </a:ext>
                  </a:extLst>
                </a:gridCol>
                <a:gridCol w="4292496">
                  <a:extLst>
                    <a:ext uri="{9D8B030D-6E8A-4147-A177-3AD203B41FA5}">
                      <a16:colId xmlns:a16="http://schemas.microsoft.com/office/drawing/2014/main" val="126904289"/>
                    </a:ext>
                  </a:extLst>
                </a:gridCol>
                <a:gridCol w="1061049">
                  <a:extLst>
                    <a:ext uri="{9D8B030D-6E8A-4147-A177-3AD203B41FA5}">
                      <a16:colId xmlns:a16="http://schemas.microsoft.com/office/drawing/2014/main" val="1603247210"/>
                    </a:ext>
                  </a:extLst>
                </a:gridCol>
                <a:gridCol w="957532">
                  <a:extLst>
                    <a:ext uri="{9D8B030D-6E8A-4147-A177-3AD203B41FA5}">
                      <a16:colId xmlns:a16="http://schemas.microsoft.com/office/drawing/2014/main" val="3148805933"/>
                    </a:ext>
                  </a:extLst>
                </a:gridCol>
                <a:gridCol w="807399">
                  <a:extLst>
                    <a:ext uri="{9D8B030D-6E8A-4147-A177-3AD203B41FA5}">
                      <a16:colId xmlns:a16="http://schemas.microsoft.com/office/drawing/2014/main" val="2269525915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therapy regimen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PT cohort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5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(%)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XT cohort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27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(%)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24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2722542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RT</a:t>
                      </a:r>
                      <a:endParaRPr lang="ja-JP" sz="10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0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0 (67)</a:t>
                      </a:r>
                      <a:endParaRPr lang="ja-JP" sz="10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0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04 (82)</a:t>
                      </a:r>
                      <a:endParaRPr lang="ja-JP" sz="10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0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851494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tri-weekly CDDP (10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004193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weekly CDDP (4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76141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weekly CBDCA (AUC=1.5)</a:t>
                      </a:r>
                      <a:endParaRPr lang="ja-JP" alt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5934239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weekly Cetuximab (40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llowed by 250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JP" alt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8349888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weekly </a:t>
                      </a:r>
                      <a:r>
                        <a:rPr kumimoji="1" lang="en-US" altLang="ja-JP" sz="900" kern="100" dirty="0" err="1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altLang="ja-JP" sz="900" kern="100" dirty="0" err="1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uperselective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intra-arterial CDDP (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alt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1731592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C followed by CCRT</a:t>
                      </a:r>
                      <a:endParaRPr lang="ja-JP" altLang="ja-JP" sz="10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3)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(15)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0442414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PF (CDDP (75 mg/m</a:t>
                      </a:r>
                      <a:r>
                        <a:rPr lang="en-US" altLang="ja-JP" sz="900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, docetaxel (75 mg/m</a:t>
                      </a:r>
                      <a:r>
                        <a:rPr lang="en-US" altLang="ja-JP" sz="900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 and 5-FU (750 mg/m</a:t>
                      </a:r>
                      <a:r>
                        <a:rPr lang="en-US" altLang="ja-JP" sz="900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) followed by concurrent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ly CDDP (4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dirty="0"/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1614226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PF (CDDP (75 mg/m</a:t>
                      </a:r>
                      <a:r>
                        <a:rPr lang="en-US" altLang="ja-JP" sz="900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, docetaxel (75 mg/m</a:t>
                      </a:r>
                      <a:r>
                        <a:rPr lang="en-US" altLang="ja-JP" sz="900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 and 5-FU (750 mg/m</a:t>
                      </a:r>
                      <a:r>
                        <a:rPr lang="en-US" altLang="ja-JP" sz="900" kern="100" baseline="30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) followed by concurrent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-weekly CDDP (10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dirty="0"/>
                    </a:p>
                  </a:txBody>
                  <a:tcP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8145985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RT followed by adjuvant chemotherapy</a:t>
                      </a:r>
                      <a:endParaRPr lang="ja-JP" altLang="ja-JP" sz="10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(20)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3)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272196"/>
                  </a:ext>
                </a:extLst>
              </a:tr>
              <a:tr h="18844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weekly CDDP (40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owed by FP (CDDP (70 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and 5-FU (700 mg/m</a:t>
                      </a:r>
                      <a:r>
                        <a:rPr kumimoji="1" lang="en-US" altLang="ja-JP" sz="9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473747"/>
                  </a:ext>
                </a:extLst>
              </a:tr>
              <a:tr h="188449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10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verage of cumulative dose of CDDP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9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(excluding the 6 patients who received CBDCA or Cetuximab in IMXT cohort)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 mg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4 mg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382</a:t>
                      </a:r>
                      <a:endParaRPr kumimoji="1" lang="ja-JP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520003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2640719-6B79-4CAD-B46B-CD70F91C212D}"/>
              </a:ext>
            </a:extLst>
          </p:cNvPr>
          <p:cNvSpPr txBox="1"/>
          <p:nvPr/>
        </p:nvSpPr>
        <p:spPr>
          <a:xfrm>
            <a:off x="74543" y="6455700"/>
            <a:ext cx="8994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AUC = area under the curve, CBDCA = carboplatin, CCRT = concurrent chemoradiotherapy, CDDP = cisplatin, IC = induction chemotherapy, N = number, 5-FU = fluorouracil. 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48041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F3D2E9-A33F-4ADA-B277-5DA2768D0C59}"/>
              </a:ext>
            </a:extLst>
          </p:cNvPr>
          <p:cNvSpPr txBox="1"/>
          <p:nvPr/>
        </p:nvSpPr>
        <p:spPr>
          <a:xfrm>
            <a:off x="0" y="12263"/>
            <a:ext cx="57508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 Waterfall plots of the delta NTCP for individual IMPT candidates.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D1BBF85-76B2-4F7F-BD5E-30B5AEB795CD}"/>
              </a:ext>
            </a:extLst>
          </p:cNvPr>
          <p:cNvSpPr txBox="1"/>
          <p:nvPr/>
        </p:nvSpPr>
        <p:spPr>
          <a:xfrm>
            <a:off x="111000" y="6546736"/>
            <a:ext cx="813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NTCP = normal-tissue complication probability, NTCP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T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NTCP value for IMPT planning, NTCP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XT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NTCP value for IMXT planning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図 22" descr="音楽 が含まれている画像&#10;&#10;自動的に生成された説明">
            <a:extLst>
              <a:ext uri="{FF2B5EF4-FFF2-40B4-BE49-F238E27FC236}">
                <a16:creationId xmlns:a16="http://schemas.microsoft.com/office/drawing/2014/main" id="{1AEB7065-19D7-44A2-A3D6-5087A08EB9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9911" y="346186"/>
            <a:ext cx="4870069" cy="6115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97596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A36B879-88EA-42F2-8F11-87742D609512}"/>
              </a:ext>
            </a:extLst>
          </p:cNvPr>
          <p:cNvSpPr txBox="1"/>
          <p:nvPr/>
        </p:nvSpPr>
        <p:spPr>
          <a:xfrm>
            <a:off x="0" y="12263"/>
            <a:ext cx="38640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4 Matched-pair analysis for dysgeusia</a:t>
            </a: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2E004A8E-242E-4311-9BB6-893272A02D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5731614"/>
              </p:ext>
            </p:extLst>
          </p:nvPr>
        </p:nvGraphicFramePr>
        <p:xfrm>
          <a:off x="1063625" y="555487"/>
          <a:ext cx="7016750" cy="5137034"/>
        </p:xfrm>
        <a:graphic>
          <a:graphicData uri="http://schemas.openxmlformats.org/drawingml/2006/table">
            <a:tbl>
              <a:tblPr firstRow="1" bandRow="1"/>
              <a:tblGrid>
                <a:gridCol w="430212">
                  <a:extLst>
                    <a:ext uri="{9D8B030D-6E8A-4147-A177-3AD203B41FA5}">
                      <a16:colId xmlns:a16="http://schemas.microsoft.com/office/drawing/2014/main" val="3162326437"/>
                    </a:ext>
                  </a:extLst>
                </a:gridCol>
                <a:gridCol w="1220300">
                  <a:extLst>
                    <a:ext uri="{9D8B030D-6E8A-4147-A177-3AD203B41FA5}">
                      <a16:colId xmlns:a16="http://schemas.microsoft.com/office/drawing/2014/main" val="3816298088"/>
                    </a:ext>
                  </a:extLst>
                </a:gridCol>
                <a:gridCol w="508488">
                  <a:extLst>
                    <a:ext uri="{9D8B030D-6E8A-4147-A177-3AD203B41FA5}">
                      <a16:colId xmlns:a16="http://schemas.microsoft.com/office/drawing/2014/main" val="391621494"/>
                    </a:ext>
                  </a:extLst>
                </a:gridCol>
                <a:gridCol w="339725">
                  <a:extLst>
                    <a:ext uri="{9D8B030D-6E8A-4147-A177-3AD203B41FA5}">
                      <a16:colId xmlns:a16="http://schemas.microsoft.com/office/drawing/2014/main" val="4161369944"/>
                    </a:ext>
                  </a:extLst>
                </a:gridCol>
                <a:gridCol w="590550">
                  <a:extLst>
                    <a:ext uri="{9D8B030D-6E8A-4147-A177-3AD203B41FA5}">
                      <a16:colId xmlns:a16="http://schemas.microsoft.com/office/drawing/2014/main" val="3626935155"/>
                    </a:ext>
                  </a:extLst>
                </a:gridCol>
                <a:gridCol w="393700">
                  <a:extLst>
                    <a:ext uri="{9D8B030D-6E8A-4147-A177-3AD203B41FA5}">
                      <a16:colId xmlns:a16="http://schemas.microsoft.com/office/drawing/2014/main" val="350943337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4025623274"/>
                    </a:ext>
                  </a:extLst>
                </a:gridCol>
                <a:gridCol w="520700">
                  <a:extLst>
                    <a:ext uri="{9D8B030D-6E8A-4147-A177-3AD203B41FA5}">
                      <a16:colId xmlns:a16="http://schemas.microsoft.com/office/drawing/2014/main" val="1382254206"/>
                    </a:ext>
                  </a:extLst>
                </a:gridCol>
                <a:gridCol w="390525">
                  <a:extLst>
                    <a:ext uri="{9D8B030D-6E8A-4147-A177-3AD203B41FA5}">
                      <a16:colId xmlns:a16="http://schemas.microsoft.com/office/drawing/2014/main" val="4089156800"/>
                    </a:ext>
                  </a:extLst>
                </a:gridCol>
                <a:gridCol w="527050">
                  <a:extLst>
                    <a:ext uri="{9D8B030D-6E8A-4147-A177-3AD203B41FA5}">
                      <a16:colId xmlns:a16="http://schemas.microsoft.com/office/drawing/2014/main" val="3058035682"/>
                    </a:ext>
                  </a:extLst>
                </a:gridCol>
                <a:gridCol w="492125">
                  <a:extLst>
                    <a:ext uri="{9D8B030D-6E8A-4147-A177-3AD203B41FA5}">
                      <a16:colId xmlns:a16="http://schemas.microsoft.com/office/drawing/2014/main" val="135603081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2035151274"/>
                    </a:ext>
                  </a:extLst>
                </a:gridCol>
              </a:tblGrid>
              <a:tr h="212725">
                <a:tc grid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ll patients (Pre-Matching)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grid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atched patients (Post-Matching)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5376865"/>
                  </a:ext>
                </a:extLst>
              </a:tr>
              <a:tr h="228600">
                <a:tc rowSpan="3"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aracteristics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MPT cohort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MXT cohort</a:t>
                      </a:r>
                      <a:endParaRPr kumimoji="1" lang="ja-JP" altLang="en-US" dirty="0"/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i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value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88265" indent="635" algn="ctr"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MPT cohort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MXT cohort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i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value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105862"/>
                  </a:ext>
                </a:extLst>
              </a:tr>
              <a:tr h="0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pPr algn="ctr"/>
                      <a:endParaRPr kumimoji="1" lang="ja-JP" altLang="en-US" dirty="0"/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dirty="0"/>
                    </a:p>
                  </a:txBody>
                  <a:tcPr marL="0" marR="0" marT="0" marB="0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%</a:t>
                      </a:r>
                      <a:endParaRPr kumimoji="1" lang="ja-JP" altLang="en-US" dirty="0"/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dirty="0"/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%</a:t>
                      </a:r>
                      <a:endParaRPr kumimoji="1" lang="ja-JP" altLang="en-US" dirty="0"/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348435"/>
                  </a:ext>
                </a:extLst>
              </a:tr>
              <a:tr h="157106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dirty="0"/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%</a:t>
                      </a:r>
                      <a:endParaRPr kumimoji="1" lang="ja-JP" altLang="en-US" dirty="0"/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dirty="0"/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%</a:t>
                      </a:r>
                      <a:endParaRPr kumimoji="1" lang="ja-JP" altLang="en-US" dirty="0"/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88265" indent="635" algn="ctr">
                        <a:spcAft>
                          <a:spcPts val="0"/>
                        </a:spcAft>
                      </a:pP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6268705"/>
                  </a:ext>
                </a:extLst>
              </a:tr>
              <a:tr h="97911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2478190"/>
                  </a:ext>
                </a:extLst>
              </a:tr>
              <a:tr h="150130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x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7865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533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9059292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ale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4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3.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1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1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3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5825404"/>
                  </a:ext>
                </a:extLst>
              </a:tr>
              <a:tr h="15013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4421204"/>
                  </a:ext>
                </a:extLst>
              </a:tr>
              <a:tr h="150130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e (years)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761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6819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5949910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8-65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1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5.9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8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708368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&gt;65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6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4.1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1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2223882"/>
                  </a:ext>
                </a:extLst>
              </a:tr>
              <a:tr h="150130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umor classification*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990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000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9392959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 0-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6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9.8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7339121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 3-4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0.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8501728"/>
                  </a:ext>
                </a:extLst>
              </a:tr>
              <a:tr h="150130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ode classification*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1989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4064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6320819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 0-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7.5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6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2234648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 2-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2.5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3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5623433"/>
                  </a:ext>
                </a:extLst>
              </a:tr>
              <a:tr h="176239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imary site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0073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*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864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4967046"/>
                  </a:ext>
                </a:extLst>
              </a:tr>
              <a:tr h="13403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sopharynx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6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.8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3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3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2013518"/>
                  </a:ext>
                </a:extLst>
              </a:tr>
              <a:tr h="125843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ropharynx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3.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8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5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1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1383331"/>
                  </a:ext>
                </a:extLst>
              </a:tr>
              <a:tr h="143765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ypopharynx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2.5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5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4381238"/>
                  </a:ext>
                </a:extLst>
              </a:tr>
              <a:tr h="176239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ose and fractions of radiation therapy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0054</a:t>
                      </a: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*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300332"/>
                  </a:ext>
                </a:extLst>
              </a:tr>
              <a:tr h="122392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0 </a:t>
                      </a:r>
                      <a:r>
                        <a:rPr lang="en-US" sz="800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(E) / 35 </a:t>
                      </a:r>
                      <a:r>
                        <a:rPr lang="en-US" sz="800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r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8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JP" sz="8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6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5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449845"/>
                  </a:ext>
                </a:extLst>
              </a:tr>
              <a:tr h="144911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1 Gy (E) / 33 fr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6566487"/>
                  </a:ext>
                </a:extLst>
              </a:tr>
              <a:tr h="133741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1.4 </a:t>
                      </a:r>
                      <a:r>
                        <a:rPr lang="en-US" sz="800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(E) / 34 </a:t>
                      </a:r>
                      <a:r>
                        <a:rPr lang="en-US" sz="800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r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.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217264"/>
                  </a:ext>
                </a:extLst>
              </a:tr>
              <a:tr h="150130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reatment modalities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0724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218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3886809"/>
                  </a:ext>
                </a:extLst>
              </a:tr>
              <a:tr h="124020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RT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6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4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1.9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5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3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6454014"/>
                  </a:ext>
                </a:extLst>
              </a:tr>
              <a:tr h="102988"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C + CCRT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3.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9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.7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0429837"/>
                  </a:ext>
                </a:extLst>
              </a:tr>
              <a:tr h="170147">
                <a:tc>
                  <a:txBody>
                    <a:bodyPr/>
                    <a:lstStyle/>
                    <a:p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RT + adjuvant </a:t>
                      </a:r>
                      <a:r>
                        <a:rPr lang="en-US" sz="800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x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.0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.1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3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723134"/>
                  </a:ext>
                </a:extLst>
              </a:tr>
              <a:tr h="56915">
                <a:tc gridSpan="6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ndpoint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4489428"/>
                  </a:ext>
                </a:extLst>
              </a:tr>
              <a:tr h="4601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ysgeusia ≥ Grade 2 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/15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6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8/76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6.3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0261*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15988" marR="15988" marT="7994" marB="79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/1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.0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/12</a:t>
                      </a:r>
                      <a:endParaRPr lang="ja-JP" sz="9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6.7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kern="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.4064</a:t>
                      </a:r>
                      <a:endParaRPr lang="ja-JP" sz="9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135432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05CFD4C-0F77-4415-9B01-98A2B7ECA304}"/>
              </a:ext>
            </a:extLst>
          </p:cNvPr>
          <p:cNvSpPr txBox="1"/>
          <p:nvPr/>
        </p:nvSpPr>
        <p:spPr>
          <a:xfrm>
            <a:off x="0" y="6253166"/>
            <a:ext cx="91440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According to the UICC TNM-classification, 8th edition.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IMPT = intensity-modulated proton therapy, IMXT = intensity modulated X-ray therapy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) = gray (cobalt gray equivalent)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fractions, CCRT = concurrent chemo-radiation therapy, IC = induction chemotherapy.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chemotherapy, NA = not applicable.</a:t>
            </a:r>
          </a:p>
        </p:txBody>
      </p:sp>
    </p:spTree>
    <p:extLst>
      <p:ext uri="{BB962C8B-B14F-4D97-AF65-F5344CB8AC3E}">
        <p14:creationId xmlns:p14="http://schemas.microsoft.com/office/powerpoint/2010/main" val="3084404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599EBE9-32DB-4D69-996E-195747D4E158}"/>
              </a:ext>
            </a:extLst>
          </p:cNvPr>
          <p:cNvSpPr txBox="1"/>
          <p:nvPr/>
        </p:nvSpPr>
        <p:spPr>
          <a:xfrm>
            <a:off x="0" y="12263"/>
            <a:ext cx="5365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5 DVH analysis for the 1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 on the 1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T and 2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T scans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8F986EA-5457-46FE-ABAD-7B4103F5D9BD}"/>
              </a:ext>
            </a:extLst>
          </p:cNvPr>
          <p:cNvSpPr txBox="1"/>
          <p:nvPr/>
        </p:nvSpPr>
        <p:spPr>
          <a:xfrm>
            <a:off x="84586" y="6279276"/>
            <a:ext cx="897482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DVH = dose-volume histogram, CTV = clinical target volume, D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%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minimum dose to 98% volume of the target, D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%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minimum dose to 95% volume of the target, D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%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minimum dose to 50% volume of the target, D</a:t>
            </a:r>
            <a:r>
              <a:rPr kumimoji="1" lang="en-US" altLang="ja-JP" sz="9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maximum dose to 2% volume of the target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9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maximum dose to the target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9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average dose to the target,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E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gray cobalt gray equivalent, delta = difference between the value of the 1</a:t>
            </a:r>
            <a:r>
              <a:rPr kumimoji="1"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 on 1</a:t>
            </a:r>
            <a:r>
              <a:rPr kumimoji="1"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T scan and re-calculated on the 2</a:t>
            </a:r>
            <a:r>
              <a:rPr kumimoji="1"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T scan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0D21C972-BEF2-482A-819C-817634884F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6953408"/>
              </p:ext>
            </p:extLst>
          </p:nvPr>
        </p:nvGraphicFramePr>
        <p:xfrm>
          <a:off x="603746" y="354475"/>
          <a:ext cx="6942597" cy="2697748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175804">
                  <a:extLst>
                    <a:ext uri="{9D8B030D-6E8A-4147-A177-3AD203B41FA5}">
                      <a16:colId xmlns:a16="http://schemas.microsoft.com/office/drawing/2014/main" val="2234154908"/>
                    </a:ext>
                  </a:extLst>
                </a:gridCol>
                <a:gridCol w="418073">
                  <a:extLst>
                    <a:ext uri="{9D8B030D-6E8A-4147-A177-3AD203B41FA5}">
                      <a16:colId xmlns:a16="http://schemas.microsoft.com/office/drawing/2014/main" val="2218314928"/>
                    </a:ext>
                  </a:extLst>
                </a:gridCol>
                <a:gridCol w="523989">
                  <a:extLst>
                    <a:ext uri="{9D8B030D-6E8A-4147-A177-3AD203B41FA5}">
                      <a16:colId xmlns:a16="http://schemas.microsoft.com/office/drawing/2014/main" val="41771969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242949910"/>
                    </a:ext>
                  </a:extLst>
                </a:gridCol>
                <a:gridCol w="353695">
                  <a:extLst>
                    <a:ext uri="{9D8B030D-6E8A-4147-A177-3AD203B41FA5}">
                      <a16:colId xmlns:a16="http://schemas.microsoft.com/office/drawing/2014/main" val="1494595064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1063388124"/>
                    </a:ext>
                  </a:extLst>
                </a:gridCol>
                <a:gridCol w="669925">
                  <a:extLst>
                    <a:ext uri="{9D8B030D-6E8A-4147-A177-3AD203B41FA5}">
                      <a16:colId xmlns:a16="http://schemas.microsoft.com/office/drawing/2014/main" val="1740515475"/>
                    </a:ext>
                  </a:extLst>
                </a:gridCol>
                <a:gridCol w="212725">
                  <a:extLst>
                    <a:ext uri="{9D8B030D-6E8A-4147-A177-3AD203B41FA5}">
                      <a16:colId xmlns:a16="http://schemas.microsoft.com/office/drawing/2014/main" val="962241551"/>
                    </a:ext>
                  </a:extLst>
                </a:gridCol>
                <a:gridCol w="349250">
                  <a:extLst>
                    <a:ext uri="{9D8B030D-6E8A-4147-A177-3AD203B41FA5}">
                      <a16:colId xmlns:a16="http://schemas.microsoft.com/office/drawing/2014/main" val="1434155354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3701427105"/>
                    </a:ext>
                  </a:extLst>
                </a:gridCol>
                <a:gridCol w="555625">
                  <a:extLst>
                    <a:ext uri="{9D8B030D-6E8A-4147-A177-3AD203B41FA5}">
                      <a16:colId xmlns:a16="http://schemas.microsoft.com/office/drawing/2014/main" val="3421097415"/>
                    </a:ext>
                  </a:extLst>
                </a:gridCol>
                <a:gridCol w="241300">
                  <a:extLst>
                    <a:ext uri="{9D8B030D-6E8A-4147-A177-3AD203B41FA5}">
                      <a16:colId xmlns:a16="http://schemas.microsoft.com/office/drawing/2014/main" val="788827905"/>
                    </a:ext>
                  </a:extLst>
                </a:gridCol>
                <a:gridCol w="371475">
                  <a:extLst>
                    <a:ext uri="{9D8B030D-6E8A-4147-A177-3AD203B41FA5}">
                      <a16:colId xmlns:a16="http://schemas.microsoft.com/office/drawing/2014/main" val="2131280423"/>
                    </a:ext>
                  </a:extLst>
                </a:gridCol>
                <a:gridCol w="317500">
                  <a:extLst>
                    <a:ext uri="{9D8B030D-6E8A-4147-A177-3AD203B41FA5}">
                      <a16:colId xmlns:a16="http://schemas.microsoft.com/office/drawing/2014/main" val="772624520"/>
                    </a:ext>
                  </a:extLst>
                </a:gridCol>
                <a:gridCol w="821056">
                  <a:extLst>
                    <a:ext uri="{9D8B030D-6E8A-4147-A177-3AD203B41FA5}">
                      <a16:colId xmlns:a16="http://schemas.microsoft.com/office/drawing/2014/main" val="185227094"/>
                    </a:ext>
                  </a:extLst>
                </a:gridCol>
              </a:tblGrid>
              <a:tr h="198187">
                <a:tc rowSpan="2" gridSpan="2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lan on 1</a:t>
                      </a:r>
                      <a:r>
                        <a:rPr kumimoji="1" lang="en-US" altLang="ja-JP" sz="10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lan re-calculated on 2</a:t>
                      </a:r>
                      <a:r>
                        <a:rPr kumimoji="1" lang="en-US" altLang="ja-JP" sz="10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ta (%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i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2722542"/>
                  </a:ext>
                </a:extLst>
              </a:tr>
              <a:tr h="198187">
                <a:tc gridSpan="2" vMerge="1"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median 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5503358"/>
                  </a:ext>
                </a:extLst>
              </a:tr>
              <a:tr h="198187">
                <a:tc row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V1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EDEDE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8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6.3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.5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5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001*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1690066"/>
                  </a:ext>
                </a:extLst>
              </a:tr>
              <a:tr h="198187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6.7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.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001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26982630"/>
                  </a:ext>
                </a:extLst>
              </a:tr>
              <a:tr h="198187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.7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001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50631989"/>
                  </a:ext>
                </a:extLst>
              </a:tr>
              <a:tr h="198187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8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8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56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7379092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instem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EDEDE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.8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58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10928068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inal co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.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29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4270903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alateral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otid glan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.9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11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72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81408393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cavity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.9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yE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4.9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88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1037271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rynx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.0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.3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.1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yE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5.8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%)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37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9900680"/>
                  </a:ext>
                </a:extLst>
              </a:tr>
            </a:tbl>
          </a:graphicData>
        </a:graphic>
      </p:graphicFrame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25E99378-C0D4-4F4F-BCA2-8EE9C090E1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514022"/>
              </p:ext>
            </p:extLst>
          </p:nvPr>
        </p:nvGraphicFramePr>
        <p:xfrm>
          <a:off x="603745" y="3186119"/>
          <a:ext cx="5165919" cy="3002548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283409">
                  <a:extLst>
                    <a:ext uri="{9D8B030D-6E8A-4147-A177-3AD203B41FA5}">
                      <a16:colId xmlns:a16="http://schemas.microsoft.com/office/drawing/2014/main" val="2234154908"/>
                    </a:ext>
                  </a:extLst>
                </a:gridCol>
                <a:gridCol w="369029">
                  <a:extLst>
                    <a:ext uri="{9D8B030D-6E8A-4147-A177-3AD203B41FA5}">
                      <a16:colId xmlns:a16="http://schemas.microsoft.com/office/drawing/2014/main" val="2218314928"/>
                    </a:ext>
                  </a:extLst>
                </a:gridCol>
                <a:gridCol w="660952">
                  <a:extLst>
                    <a:ext uri="{9D8B030D-6E8A-4147-A177-3AD203B41FA5}">
                      <a16:colId xmlns:a16="http://schemas.microsoft.com/office/drawing/2014/main" val="41771969"/>
                    </a:ext>
                  </a:extLst>
                </a:gridCol>
                <a:gridCol w="173935">
                  <a:extLst>
                    <a:ext uri="{9D8B030D-6E8A-4147-A177-3AD203B41FA5}">
                      <a16:colId xmlns:a16="http://schemas.microsoft.com/office/drawing/2014/main" val="1242949910"/>
                    </a:ext>
                  </a:extLst>
                </a:gridCol>
                <a:gridCol w="601317">
                  <a:extLst>
                    <a:ext uri="{9D8B030D-6E8A-4147-A177-3AD203B41FA5}">
                      <a16:colId xmlns:a16="http://schemas.microsoft.com/office/drawing/2014/main" val="1494595064"/>
                    </a:ext>
                  </a:extLst>
                </a:gridCol>
                <a:gridCol w="660952">
                  <a:extLst>
                    <a:ext uri="{9D8B030D-6E8A-4147-A177-3AD203B41FA5}">
                      <a16:colId xmlns:a16="http://schemas.microsoft.com/office/drawing/2014/main" val="1740515475"/>
                    </a:ext>
                  </a:extLst>
                </a:gridCol>
                <a:gridCol w="129209">
                  <a:extLst>
                    <a:ext uri="{9D8B030D-6E8A-4147-A177-3AD203B41FA5}">
                      <a16:colId xmlns:a16="http://schemas.microsoft.com/office/drawing/2014/main" val="962241551"/>
                    </a:ext>
                  </a:extLst>
                </a:gridCol>
                <a:gridCol w="615334">
                  <a:extLst>
                    <a:ext uri="{9D8B030D-6E8A-4147-A177-3AD203B41FA5}">
                      <a16:colId xmlns:a16="http://schemas.microsoft.com/office/drawing/2014/main" val="1434155354"/>
                    </a:ext>
                  </a:extLst>
                </a:gridCol>
                <a:gridCol w="671782">
                  <a:extLst>
                    <a:ext uri="{9D8B030D-6E8A-4147-A177-3AD203B41FA5}">
                      <a16:colId xmlns:a16="http://schemas.microsoft.com/office/drawing/2014/main" val="185227094"/>
                    </a:ext>
                  </a:extLst>
                </a:gridCol>
              </a:tblGrid>
              <a:tr h="198187">
                <a:tc rowSpan="2" gridSpan="2">
                  <a:txBody>
                    <a:bodyPr/>
                    <a:lstStyle/>
                    <a:p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ta (%) for the patients with body weight changes  &lt;2.1% (N=7)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ta (%) for the patients with body weight changes ≥2.1%</a:t>
                      </a:r>
                    </a:p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8)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i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2722542"/>
                  </a:ext>
                </a:extLst>
              </a:tr>
              <a:tr h="198187">
                <a:tc gridSpan="2" vMerge="1"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median 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median 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5503358"/>
                  </a:ext>
                </a:extLst>
              </a:tr>
              <a:tr h="198187">
                <a:tc row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V1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EDEDE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8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1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5 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3.8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 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000</a:t>
                      </a:r>
                    </a:p>
                  </a:txBody>
                  <a:tcPr marL="3175" marR="3175" marT="31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1690066"/>
                  </a:ext>
                </a:extLst>
              </a:tr>
              <a:tr h="198187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.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00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26982630"/>
                  </a:ext>
                </a:extLst>
              </a:tr>
              <a:tr h="198187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538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50631989"/>
                  </a:ext>
                </a:extLst>
              </a:tr>
              <a:tr h="198187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%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85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7379092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instem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EDEDE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0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.6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1.2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.3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079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10928068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inal co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0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1.4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1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03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4270903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alateral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otid glan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8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.7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11.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.9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875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81408393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cavity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4.3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.1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5.6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0 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030</a:t>
                      </a:r>
                    </a:p>
                  </a:txBody>
                  <a:tcPr marL="3175" marR="3175" marT="317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1037271"/>
                  </a:ext>
                </a:extLst>
              </a:tr>
              <a:tr h="19818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rynx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9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L>
                      <a:noFill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4.5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5 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+9.2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2 </a:t>
                      </a: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491*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99006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53144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ppt1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alibri">
      <a:majorFont>
        <a:latin typeface="Calibri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ppt1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3</TotalTime>
  <Words>2010</Words>
  <Application>Microsoft Office PowerPoint</Application>
  <PresentationFormat>画面に合わせる (4:3)</PresentationFormat>
  <Paragraphs>703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7</vt:i4>
      </vt:variant>
    </vt:vector>
  </HeadingPairs>
  <TitlesOfParts>
    <vt:vector size="17" baseType="lpstr">
      <vt:lpstr>ヒラギノ丸ゴ Pro W4</vt:lpstr>
      <vt:lpstr>游ゴシック</vt:lpstr>
      <vt:lpstr>游明朝</vt:lpstr>
      <vt:lpstr>Arial</vt:lpstr>
      <vt:lpstr>Calibri</vt:lpstr>
      <vt:lpstr>Calibri Light</vt:lpstr>
      <vt:lpstr>Franklin Gothic Demi</vt:lpstr>
      <vt:lpstr>Times New Roman</vt:lpstr>
      <vt:lpstr>Office テーマ</vt:lpstr>
      <vt:lpstr>ppt1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安田耕一</dc:creator>
  <cp:keywords/>
  <dc:description/>
  <cp:lastModifiedBy>Yasuda Koichi</cp:lastModifiedBy>
  <cp:revision>197</cp:revision>
  <dcterms:created xsi:type="dcterms:W3CDTF">2019-07-13T08:46:44Z</dcterms:created>
  <dcterms:modified xsi:type="dcterms:W3CDTF">2020-11-08T04:45:03Z</dcterms:modified>
  <cp:category/>
</cp:coreProperties>
</file>